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7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32EB284F-7949-FC44-AED4-8C4F679D9722}">
          <p14:sldIdLst>
            <p14:sldId id="297"/>
          </p14:sldIdLst>
        </p14:section>
      </p14:sectionLst>
    </p:ex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7F85FF"/>
    <a:srgbClr val="FC5653"/>
    <a:srgbClr val="FEA0A1"/>
    <a:srgbClr val="FD695A"/>
    <a:srgbClr val="9BADFF"/>
    <a:srgbClr val="495EFF"/>
    <a:srgbClr val="61FF58"/>
    <a:srgbClr val="84FF7D"/>
    <a:srgbClr val="22FF09"/>
    <a:srgbClr val="69CA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067" autoAdjust="0"/>
    <p:restoredTop sz="92475" autoAdjust="0"/>
  </p:normalViewPr>
  <p:slideViewPr>
    <p:cSldViewPr snapToGrid="0" snapToObjects="1">
      <p:cViewPr>
        <p:scale>
          <a:sx n="201" d="100"/>
          <a:sy n="201" d="100"/>
        </p:scale>
        <p:origin x="-760" y="364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an:Desktop:predict_causual_genes:validation:Setaria_QTL:compare%20candidate%20genes%20in%20Siv%20and%20Sit:Sue's%20analysis:Supplemental%20table%204%20QTG_DE_candidates_Elen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8949193850769"/>
          <c:y val="0.034805890227577"/>
          <c:w val="0.654269403824522"/>
          <c:h val="0.57384224562291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evir.5G394900!$C$48</c:f>
              <c:strCache>
                <c:ptCount val="1"/>
                <c:pt idx="0">
                  <c:v>Setaria italica</c:v>
                </c:pt>
              </c:strCache>
            </c:strRef>
          </c:tx>
          <c:spPr>
            <a:solidFill>
              <a:schemeClr val="accent5">
                <a:lumMod val="75000"/>
              </a:schemeClr>
            </a:solidFill>
            <a:effectLst/>
          </c:spPr>
          <c:invertIfNegative val="0"/>
          <c:cat>
            <c:strRef>
              <c:f>Sevir.5G394900!$B$49:$B$64</c:f>
              <c:strCache>
                <c:ptCount val="16"/>
                <c:pt idx="0">
                  <c:v>Germ shoot 6d.dark mesh water</c:v>
                </c:pt>
                <c:pt idx="1">
                  <c:v>Leaf 2 2wk.highlight</c:v>
                </c:pt>
                <c:pt idx="2">
                  <c:v>Leaf 3 2wk.highlight</c:v>
                </c:pt>
                <c:pt idx="3">
                  <c:v>Leaf 4 2wk.highlight</c:v>
                </c:pt>
                <c:pt idx="4">
                  <c:v>Leaf 5 2wk.highlight</c:v>
                </c:pt>
                <c:pt idx="5">
                  <c:v>Leaf 6 2wk.highlight</c:v>
                </c:pt>
                <c:pt idx="6">
                  <c:v>Root 10d.light</c:v>
                </c:pt>
                <c:pt idx="7">
                  <c:v>Root.ammonia</c:v>
                </c:pt>
                <c:pt idx="8">
                  <c:v>Root.drought</c:v>
                </c:pt>
                <c:pt idx="9">
                  <c:v>Root.nitrate</c:v>
                </c:pt>
                <c:pt idx="10">
                  <c:v>Root.urea</c:v>
                </c:pt>
                <c:pt idx="11">
                  <c:v>Shoot 1wk.highlight</c:v>
                </c:pt>
                <c:pt idx="12">
                  <c:v>Total aerial.blue light</c:v>
                </c:pt>
                <c:pt idx="13">
                  <c:v>Total aerial.dark</c:v>
                </c:pt>
                <c:pt idx="14">
                  <c:v>Total aerial.far red light</c:v>
                </c:pt>
                <c:pt idx="15">
                  <c:v>Total aerial.red light</c:v>
                </c:pt>
              </c:strCache>
            </c:strRef>
          </c:cat>
          <c:val>
            <c:numRef>
              <c:f>Sevir.5G394900!$C$49:$C$64</c:f>
              <c:numCache>
                <c:formatCode>General</c:formatCode>
                <c:ptCount val="16"/>
                <c:pt idx="0">
                  <c:v>113.736</c:v>
                </c:pt>
                <c:pt idx="1">
                  <c:v>19.968</c:v>
                </c:pt>
                <c:pt idx="2">
                  <c:v>14.618</c:v>
                </c:pt>
                <c:pt idx="3">
                  <c:v>10.008</c:v>
                </c:pt>
                <c:pt idx="4">
                  <c:v>25.64</c:v>
                </c:pt>
                <c:pt idx="5">
                  <c:v>235.571</c:v>
                </c:pt>
                <c:pt idx="6">
                  <c:v>136.382</c:v>
                </c:pt>
                <c:pt idx="7">
                  <c:v>172.055</c:v>
                </c:pt>
                <c:pt idx="8">
                  <c:v>84.77299999999998</c:v>
                </c:pt>
                <c:pt idx="9">
                  <c:v>178.101</c:v>
                </c:pt>
                <c:pt idx="10">
                  <c:v>127.375</c:v>
                </c:pt>
                <c:pt idx="11">
                  <c:v>186.297</c:v>
                </c:pt>
                <c:pt idx="12">
                  <c:v>32.416</c:v>
                </c:pt>
                <c:pt idx="13">
                  <c:v>87.432</c:v>
                </c:pt>
                <c:pt idx="14">
                  <c:v>22.66</c:v>
                </c:pt>
                <c:pt idx="15">
                  <c:v>85.6249999999999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499-A147-B055-A3177764783D}"/>
            </c:ext>
          </c:extLst>
        </c:ser>
        <c:ser>
          <c:idx val="1"/>
          <c:order val="1"/>
          <c:tx>
            <c:strRef>
              <c:f>Sevir.5G394900!$D$48</c:f>
              <c:strCache>
                <c:ptCount val="1"/>
                <c:pt idx="0">
                  <c:v>Setaria viridis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  <a:effectLst/>
          </c:spPr>
          <c:invertIfNegative val="0"/>
          <c:cat>
            <c:strRef>
              <c:f>Sevir.5G394900!$B$49:$B$64</c:f>
              <c:strCache>
                <c:ptCount val="16"/>
                <c:pt idx="0">
                  <c:v>Germ shoot 6d.dark mesh water</c:v>
                </c:pt>
                <c:pt idx="1">
                  <c:v>Leaf 2 2wk.highlight</c:v>
                </c:pt>
                <c:pt idx="2">
                  <c:v>Leaf 3 2wk.highlight</c:v>
                </c:pt>
                <c:pt idx="3">
                  <c:v>Leaf 4 2wk.highlight</c:v>
                </c:pt>
                <c:pt idx="4">
                  <c:v>Leaf 5 2wk.highlight</c:v>
                </c:pt>
                <c:pt idx="5">
                  <c:v>Leaf 6 2wk.highlight</c:v>
                </c:pt>
                <c:pt idx="6">
                  <c:v>Root 10d.light</c:v>
                </c:pt>
                <c:pt idx="7">
                  <c:v>Root.ammonia</c:v>
                </c:pt>
                <c:pt idx="8">
                  <c:v>Root.drought</c:v>
                </c:pt>
                <c:pt idx="9">
                  <c:v>Root.nitrate</c:v>
                </c:pt>
                <c:pt idx="10">
                  <c:v>Root.urea</c:v>
                </c:pt>
                <c:pt idx="11">
                  <c:v>Shoot 1wk.highlight</c:v>
                </c:pt>
                <c:pt idx="12">
                  <c:v>Total aerial.blue light</c:v>
                </c:pt>
                <c:pt idx="13">
                  <c:v>Total aerial.dark</c:v>
                </c:pt>
                <c:pt idx="14">
                  <c:v>Total aerial.far red light</c:v>
                </c:pt>
                <c:pt idx="15">
                  <c:v>Total aerial.red light</c:v>
                </c:pt>
              </c:strCache>
            </c:strRef>
          </c:cat>
          <c:val>
            <c:numRef>
              <c:f>Sevir.5G394900!$D$49:$D$64</c:f>
              <c:numCache>
                <c:formatCode>General</c:formatCode>
                <c:ptCount val="16"/>
                <c:pt idx="0">
                  <c:v>52.466</c:v>
                </c:pt>
                <c:pt idx="1">
                  <c:v>9.43</c:v>
                </c:pt>
                <c:pt idx="2">
                  <c:v>12.082</c:v>
                </c:pt>
                <c:pt idx="3">
                  <c:v>5.433</c:v>
                </c:pt>
                <c:pt idx="4">
                  <c:v>9.734</c:v>
                </c:pt>
                <c:pt idx="5">
                  <c:v>91.18299999999998</c:v>
                </c:pt>
                <c:pt idx="6">
                  <c:v>69.264</c:v>
                </c:pt>
                <c:pt idx="7">
                  <c:v>68.406</c:v>
                </c:pt>
                <c:pt idx="8">
                  <c:v>44.303</c:v>
                </c:pt>
                <c:pt idx="9">
                  <c:v>83.532</c:v>
                </c:pt>
                <c:pt idx="10">
                  <c:v>70.772</c:v>
                </c:pt>
                <c:pt idx="11">
                  <c:v>114.415</c:v>
                </c:pt>
                <c:pt idx="12">
                  <c:v>16.834</c:v>
                </c:pt>
                <c:pt idx="13">
                  <c:v>20.534</c:v>
                </c:pt>
                <c:pt idx="14">
                  <c:v>11.863</c:v>
                </c:pt>
                <c:pt idx="15">
                  <c:v>53.18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0499-A147-B055-A317776478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38781352"/>
        <c:axId val="-2132221384"/>
      </c:barChart>
      <c:catAx>
        <c:axId val="-213878135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txPr>
          <a:bodyPr/>
          <a:lstStyle/>
          <a:p>
            <a:pPr>
              <a:defRPr sz="1100"/>
            </a:pPr>
            <a:endParaRPr lang="en-US"/>
          </a:p>
        </c:txPr>
        <c:crossAx val="-2132221384"/>
        <c:crosses val="autoZero"/>
        <c:auto val="1"/>
        <c:lblAlgn val="ctr"/>
        <c:lblOffset val="100"/>
        <c:noMultiLvlLbl val="0"/>
      </c:catAx>
      <c:valAx>
        <c:axId val="-213222138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PKM</a:t>
                </a:r>
              </a:p>
            </c:rich>
          </c:tx>
          <c:layout>
            <c:manualLayout>
              <c:xMode val="edge"/>
              <c:yMode val="edge"/>
              <c:x val="0.091196100487439"/>
              <c:y val="0.27399281128935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crossAx val="-2138781352"/>
        <c:crosses val="autoZero"/>
        <c:crossBetween val="between"/>
      </c:valAx>
      <c:spPr>
        <a:ln>
          <a:solidFill>
            <a:schemeClr val="tx1"/>
          </a:solidFill>
        </a:ln>
      </c:spPr>
    </c:plotArea>
    <c:legend>
      <c:legendPos val="r"/>
      <c:legendEntry>
        <c:idx val="0"/>
        <c:txPr>
          <a:bodyPr/>
          <a:lstStyle/>
          <a:p>
            <a:pPr>
              <a:defRPr i="1"/>
            </a:pPr>
            <a:endParaRPr lang="en-US"/>
          </a:p>
        </c:txPr>
      </c:legendEntry>
      <c:legendEntry>
        <c:idx val="1"/>
        <c:txPr>
          <a:bodyPr/>
          <a:lstStyle/>
          <a:p>
            <a:pPr>
              <a:defRPr i="1"/>
            </a:pPr>
            <a:endParaRPr lang="en-US"/>
          </a:p>
        </c:txPr>
      </c:legendEntry>
      <c:layout>
        <c:manualLayout>
          <c:xMode val="edge"/>
          <c:yMode val="edge"/>
          <c:x val="0.67152418447694"/>
          <c:y val="0.0468068978056251"/>
          <c:w val="0.175188601424822"/>
          <c:h val="0.100056222989888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D5368F-1C20-2147-933B-25F31BF077BE}" type="datetimeFigureOut">
              <a:rPr lang="en-US" smtClean="0"/>
              <a:t>2/2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157C04-4056-9946-94CB-039BCFF2D2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0229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aseline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E157C04-4056-9946-94CB-039BCFF2D2C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29098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7204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5563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275167"/>
            <a:ext cx="1543050" cy="585046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275167"/>
            <a:ext cx="4514850" cy="585046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08484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8804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70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237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1600204"/>
            <a:ext cx="3028950" cy="452543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1600204"/>
            <a:ext cx="3028950" cy="452543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70301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5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21"/>
            <a:ext cx="3030141" cy="85301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046821"/>
            <a:ext cx="3031331" cy="85301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9858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0794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1916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64069"/>
            <a:ext cx="2256235" cy="154940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53427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2"/>
            <a:ext cx="4114800" cy="75565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3"/>
            <a:ext cx="4114800" cy="10731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43522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5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3"/>
            <a:ext cx="21717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074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phytozome.jgi.doe.gov/phytomine/aspect.do?name=Expression" TargetMode="External"/><Relationship Id="rId4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587201" y="6266590"/>
            <a:ext cx="6005817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/>
              <a:t>Supplemental Figure S10 A candidate gene encoding </a:t>
            </a:r>
            <a:r>
              <a:rPr lang="en-US" sz="1200" dirty="0">
                <a:solidFill>
                  <a:srgbClr val="000000"/>
                </a:solidFill>
                <a:ea typeface="Calibri"/>
                <a:cs typeface="Calibri"/>
              </a:rPr>
              <a:t>a ribosomal protein in the L1P family has higher expression in </a:t>
            </a:r>
            <a:r>
              <a:rPr lang="en-US" sz="1200" i="1" dirty="0">
                <a:solidFill>
                  <a:srgbClr val="000000"/>
                </a:solidFill>
                <a:ea typeface="Calibri"/>
                <a:cs typeface="Calibri"/>
              </a:rPr>
              <a:t>Setaria italica </a:t>
            </a:r>
            <a:r>
              <a:rPr lang="en-US" sz="1200" dirty="0">
                <a:solidFill>
                  <a:srgbClr val="000000"/>
                </a:solidFill>
                <a:ea typeface="Calibri"/>
                <a:cs typeface="Calibri"/>
              </a:rPr>
              <a:t>(</a:t>
            </a:r>
            <a:r>
              <a:rPr lang="de-DE" sz="1200" dirty="0">
                <a:solidFill>
                  <a:srgbClr val="000000"/>
                </a:solidFill>
                <a:ea typeface="Calibri"/>
                <a:cs typeface="Calibri"/>
              </a:rPr>
              <a:t>Seita.5G389700</a:t>
            </a:r>
            <a:r>
              <a:rPr lang="en-US" sz="1200" dirty="0">
                <a:solidFill>
                  <a:srgbClr val="000000"/>
                </a:solidFill>
                <a:ea typeface="Calibri"/>
                <a:cs typeface="Calibri"/>
              </a:rPr>
              <a:t>)</a:t>
            </a:r>
            <a:r>
              <a:rPr lang="en-US" sz="1200" i="1" dirty="0">
                <a:solidFill>
                  <a:srgbClr val="000000"/>
                </a:solidFill>
                <a:ea typeface="Calibri"/>
                <a:cs typeface="Calibri"/>
              </a:rPr>
              <a:t> </a:t>
            </a:r>
            <a:r>
              <a:rPr lang="en-US" sz="1200" dirty="0">
                <a:solidFill>
                  <a:srgbClr val="000000"/>
                </a:solidFill>
                <a:ea typeface="Calibri"/>
                <a:cs typeface="Calibri"/>
              </a:rPr>
              <a:t>than in </a:t>
            </a:r>
            <a:r>
              <a:rPr lang="en-US" sz="1200" i="1" dirty="0" err="1">
                <a:solidFill>
                  <a:srgbClr val="000000"/>
                </a:solidFill>
                <a:ea typeface="Calibri"/>
                <a:cs typeface="Calibri"/>
              </a:rPr>
              <a:t>Setaria</a:t>
            </a:r>
            <a:r>
              <a:rPr lang="en-US" sz="1200" i="1" dirty="0">
                <a:solidFill>
                  <a:srgbClr val="000000"/>
                </a:solidFill>
                <a:ea typeface="Calibri"/>
                <a:cs typeface="Calibri"/>
              </a:rPr>
              <a:t> viridis </a:t>
            </a:r>
            <a:r>
              <a:rPr lang="en-US" sz="1200" dirty="0">
                <a:solidFill>
                  <a:srgbClr val="000000"/>
                </a:solidFill>
                <a:ea typeface="Calibri"/>
                <a:cs typeface="Calibri"/>
              </a:rPr>
              <a:t>(Sevir.5G394900)</a:t>
            </a:r>
            <a:r>
              <a:rPr lang="en-US" sz="1200" i="1" dirty="0">
                <a:solidFill>
                  <a:srgbClr val="000000"/>
                </a:solidFill>
                <a:ea typeface="Calibri"/>
                <a:cs typeface="Calibri"/>
              </a:rPr>
              <a:t>. </a:t>
            </a:r>
            <a:r>
              <a:rPr lang="en-US" sz="1200" dirty="0" err="1">
                <a:solidFill>
                  <a:srgbClr val="000000"/>
                </a:solidFill>
                <a:ea typeface="Calibri"/>
                <a:cs typeface="Calibri"/>
              </a:rPr>
              <a:t>RNAseq</a:t>
            </a:r>
            <a:r>
              <a:rPr lang="en-US" sz="1200" dirty="0">
                <a:solidFill>
                  <a:srgbClr val="000000"/>
                </a:solidFill>
                <a:ea typeface="Calibri"/>
                <a:cs typeface="Calibri"/>
              </a:rPr>
              <a:t> data were </a:t>
            </a:r>
            <a:r>
              <a:rPr lang="en-US" sz="1200" dirty="0" smtClean="0">
                <a:solidFill>
                  <a:srgbClr val="000000"/>
                </a:solidFill>
                <a:ea typeface="Calibri"/>
                <a:cs typeface="Calibri"/>
              </a:rPr>
              <a:t>downloaded </a:t>
            </a:r>
            <a:r>
              <a:rPr lang="en-US" sz="1200" dirty="0">
                <a:solidFill>
                  <a:srgbClr val="000000"/>
                </a:solidFill>
                <a:ea typeface="Calibri"/>
                <a:cs typeface="Calibri"/>
              </a:rPr>
              <a:t>from the gene page of </a:t>
            </a:r>
            <a:r>
              <a:rPr lang="en-US" sz="1200" dirty="0" err="1">
                <a:solidFill>
                  <a:srgbClr val="000000"/>
                </a:solidFill>
                <a:ea typeface="Calibri"/>
                <a:cs typeface="Calibri"/>
              </a:rPr>
              <a:t>Phytozome</a:t>
            </a:r>
            <a:r>
              <a:rPr lang="en-US" sz="1200" dirty="0">
                <a:solidFill>
                  <a:srgbClr val="000000"/>
                </a:solidFill>
                <a:ea typeface="Calibri"/>
                <a:cs typeface="Calibri"/>
              </a:rPr>
              <a:t> v12. FPKM, Fragments Per </a:t>
            </a:r>
            <a:r>
              <a:rPr lang="en-US" sz="1200" dirty="0" err="1">
                <a:solidFill>
                  <a:srgbClr val="000000"/>
                </a:solidFill>
                <a:ea typeface="Calibri"/>
                <a:cs typeface="Calibri"/>
              </a:rPr>
              <a:t>Kilobase</a:t>
            </a:r>
            <a:r>
              <a:rPr lang="en-US" sz="1200" dirty="0">
                <a:solidFill>
                  <a:srgbClr val="000000"/>
                </a:solidFill>
                <a:ea typeface="Calibri"/>
                <a:cs typeface="Calibri"/>
              </a:rPr>
              <a:t> of transcript per Million mapped reads. Cyan indicates gene expression in </a:t>
            </a:r>
            <a:r>
              <a:rPr lang="en-US" sz="1200" i="1" dirty="0">
                <a:solidFill>
                  <a:srgbClr val="000000"/>
                </a:solidFill>
                <a:ea typeface="Calibri"/>
                <a:cs typeface="Calibri"/>
              </a:rPr>
              <a:t>Setaria italica </a:t>
            </a:r>
            <a:r>
              <a:rPr lang="en-US" sz="1200" dirty="0">
                <a:solidFill>
                  <a:srgbClr val="000000"/>
                </a:solidFill>
                <a:ea typeface="Calibri"/>
                <a:cs typeface="Calibri"/>
              </a:rPr>
              <a:t>and orange indicates gene expression in </a:t>
            </a:r>
            <a:r>
              <a:rPr lang="en-US" sz="1200" i="1" dirty="0">
                <a:solidFill>
                  <a:srgbClr val="000000"/>
                </a:solidFill>
                <a:ea typeface="Calibri"/>
                <a:cs typeface="Calibri"/>
              </a:rPr>
              <a:t>Setaria viridis</a:t>
            </a:r>
            <a:r>
              <a:rPr lang="en-US" sz="1200" dirty="0">
                <a:solidFill>
                  <a:srgbClr val="000000"/>
                </a:solidFill>
                <a:ea typeface="Calibri"/>
                <a:cs typeface="Calibri"/>
              </a:rPr>
              <a:t>. Sample names describe the tissue and treatment, which are separated by a dot in the name. Detailed sample description can be found at </a:t>
            </a:r>
            <a:r>
              <a:rPr lang="en-US" sz="1200" dirty="0">
                <a:solidFill>
                  <a:srgbClr val="000000"/>
                </a:solidFill>
                <a:ea typeface="Calibri"/>
                <a:cs typeface="Calibri"/>
                <a:hlinkClick r:id="rId3"/>
              </a:rPr>
              <a:t>https://phytozome.jgi.doe.gov/phytomine/aspect.do?name=Expression</a:t>
            </a:r>
            <a:r>
              <a:rPr lang="en-US" sz="1200" dirty="0">
                <a:solidFill>
                  <a:srgbClr val="000000"/>
                </a:solidFill>
                <a:ea typeface="Calibri"/>
                <a:cs typeface="Calibri"/>
              </a:rPr>
              <a:t>. </a:t>
            </a:r>
            <a:endParaRPr lang="en-US" sz="1200" dirty="0"/>
          </a:p>
        </p:txBody>
      </p:sp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30065989"/>
              </p:ext>
            </p:extLst>
          </p:nvPr>
        </p:nvGraphicFramePr>
        <p:xfrm>
          <a:off x="680587" y="2824809"/>
          <a:ext cx="5334000" cy="32660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18390729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127</TotalTime>
  <Words>116</Words>
  <Application>Microsoft Macintosh PowerPoint</Application>
  <PresentationFormat>Letter Paper (8.5x11 in)</PresentationFormat>
  <Paragraphs>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n Lin</dc:creator>
  <cp:lastModifiedBy>Fan Lin</cp:lastModifiedBy>
  <cp:revision>1273</cp:revision>
  <cp:lastPrinted>2020-01-29T19:46:17Z</cp:lastPrinted>
  <dcterms:created xsi:type="dcterms:W3CDTF">2018-04-05T21:34:21Z</dcterms:created>
  <dcterms:modified xsi:type="dcterms:W3CDTF">2020-02-03T04:21:05Z</dcterms:modified>
</cp:coreProperties>
</file>